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33421-69B6-45D6-9515-B6459FD6FB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B7892-B8E1-4D6E-8CE8-87EBFA0A94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82378-0979-4178-A1B2-E01D46621A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C5061-A254-4B7A-A769-B883A09A7A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19BD73-9E82-476E-B1E3-00021CD05C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18E92-F059-41C9-AA67-F40985F8ED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42B06-926F-4D70-9C80-074EE6815F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2E200-7897-44AA-907C-2B149E16B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DB0D9-82FA-4493-B5C4-8E37C09F26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76200-2D81-486D-8771-C0B001FE08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3C2A4-F936-483F-AA2E-4EB3BD3E3D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31ADD-6B38-44D7-A342-B3290F4D0E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802BB24-CC6D-4F16-80C3-FB000D38452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8D3644-359B-4A8F-A6A4-274080BFD45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955880" y="914400"/>
            <a:ext cx="2419200" cy="51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1951200" y="372960"/>
            <a:ext cx="2423880" cy="51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모서리가 둥근 직사각형 3"/>
          <p:cNvSpPr/>
          <p:nvPr/>
        </p:nvSpPr>
        <p:spPr>
          <a:xfrm>
            <a:off x="1822320" y="307800"/>
            <a:ext cx="2673360" cy="12049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7964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직사각형 4"/>
          <p:cNvSpPr/>
          <p:nvPr/>
        </p:nvSpPr>
        <p:spPr>
          <a:xfrm>
            <a:off x="1650960" y="1503360"/>
            <a:ext cx="299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perimentally validated databas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모서리가 둥근 직사각형 6"/>
          <p:cNvSpPr/>
          <p:nvPr/>
        </p:nvSpPr>
        <p:spPr>
          <a:xfrm>
            <a:off x="5243400" y="307800"/>
            <a:ext cx="2671920" cy="1221120"/>
          </a:xfrm>
          <a:prstGeom prst="roundRect">
            <a:avLst>
              <a:gd name="adj" fmla="val 16667"/>
            </a:avLst>
          </a:prstGeom>
          <a:noFill/>
          <a:ln w="25560">
            <a:solidFill>
              <a:srgbClr val="f7964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" descr=""/>
          <p:cNvPicPr/>
          <p:nvPr/>
        </p:nvPicPr>
        <p:blipFill>
          <a:blip r:embed="rId3"/>
          <a:stretch/>
        </p:blipFill>
        <p:spPr>
          <a:xfrm>
            <a:off x="5394240" y="372960"/>
            <a:ext cx="2376720" cy="1117800"/>
          </a:xfrm>
          <a:prstGeom prst="rect">
            <a:avLst/>
          </a:prstGeom>
          <a:ln w="0">
            <a:noFill/>
          </a:ln>
        </p:spPr>
      </p:pic>
      <p:sp>
        <p:nvSpPr>
          <p:cNvPr id="47" name="직사각형 5"/>
          <p:cNvSpPr/>
          <p:nvPr/>
        </p:nvSpPr>
        <p:spPr>
          <a:xfrm>
            <a:off x="5002560" y="1504800"/>
            <a:ext cx="3271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ext-mining of cancer-related context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직사각형 7"/>
          <p:cNvSpPr/>
          <p:nvPr/>
        </p:nvSpPr>
        <p:spPr>
          <a:xfrm>
            <a:off x="1712880" y="255600"/>
            <a:ext cx="6407280" cy="1593720"/>
          </a:xfrm>
          <a:prstGeom prst="rect">
            <a:avLst/>
          </a:prstGeom>
          <a:noFill/>
          <a:ln w="25560">
            <a:solidFill>
              <a:srgbClr val="4bacc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직사각형 8"/>
          <p:cNvSpPr/>
          <p:nvPr/>
        </p:nvSpPr>
        <p:spPr>
          <a:xfrm>
            <a:off x="1712880" y="3132000"/>
            <a:ext cx="640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Joint expression profiling of miRNAs and mRNAs in antiestrogen resista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직사각형 14"/>
          <p:cNvSpPr/>
          <p:nvPr/>
        </p:nvSpPr>
        <p:spPr>
          <a:xfrm>
            <a:off x="1712880" y="2143080"/>
            <a:ext cx="6407280" cy="1320840"/>
          </a:xfrm>
          <a:prstGeom prst="rect">
            <a:avLst/>
          </a:prstGeom>
          <a:noFill/>
          <a:ln w="25560">
            <a:solidFill>
              <a:srgbClr val="4bacc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1"/>
          <p:cNvSpPr/>
          <p:nvPr/>
        </p:nvSpPr>
        <p:spPr>
          <a:xfrm>
            <a:off x="1739880" y="4886280"/>
            <a:ext cx="638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ntegrative network with miRNAs, mRNAs, expressions, and cancer-related contex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37"/>
          <p:cNvSpPr/>
          <p:nvPr/>
        </p:nvSpPr>
        <p:spPr>
          <a:xfrm>
            <a:off x="2405160" y="6472080"/>
            <a:ext cx="499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etwork cluster extra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직사각형 20"/>
          <p:cNvSpPr/>
          <p:nvPr/>
        </p:nvSpPr>
        <p:spPr>
          <a:xfrm>
            <a:off x="1712880" y="3747960"/>
            <a:ext cx="6407280" cy="1471680"/>
          </a:xfrm>
          <a:prstGeom prst="rect">
            <a:avLst/>
          </a:prstGeom>
          <a:noFill/>
          <a:ln w="25560">
            <a:solidFill>
              <a:srgbClr val="4bacc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0"/>
          <p:cNvSpPr/>
          <p:nvPr/>
        </p:nvSpPr>
        <p:spPr>
          <a:xfrm>
            <a:off x="2940120" y="5580000"/>
            <a:ext cx="3927240" cy="916920"/>
          </a:xfrm>
          <a:prstGeom prst="rect">
            <a:avLst/>
          </a:prstGeom>
          <a:solidFill>
            <a:srgbClr val="ffffff"/>
          </a:solidFill>
          <a:ln w="648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직사각형 23"/>
          <p:cNvSpPr/>
          <p:nvPr/>
        </p:nvSpPr>
        <p:spPr>
          <a:xfrm>
            <a:off x="1712880" y="5500800"/>
            <a:ext cx="6407280" cy="1303200"/>
          </a:xfrm>
          <a:prstGeom prst="rect">
            <a:avLst/>
          </a:prstGeom>
          <a:noFill/>
          <a:ln w="25560">
            <a:solidFill>
              <a:srgbClr val="4bacc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순서도: 병합 29"/>
          <p:cNvSpPr/>
          <p:nvPr/>
        </p:nvSpPr>
        <p:spPr>
          <a:xfrm>
            <a:off x="4532400" y="5226120"/>
            <a:ext cx="664920" cy="217440"/>
          </a:xfrm>
          <a:prstGeom prst="flowChartMerg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 26"/>
          <p:cNvGrpSpPr/>
          <p:nvPr/>
        </p:nvGrpSpPr>
        <p:grpSpPr>
          <a:xfrm>
            <a:off x="2952720" y="3852720"/>
            <a:ext cx="3927600" cy="916920"/>
            <a:chOff x="2952720" y="3852720"/>
            <a:chExt cx="3927600" cy="916920"/>
          </a:xfrm>
        </p:grpSpPr>
        <p:sp>
          <p:nvSpPr>
            <p:cNvPr id="58" name="TextBox 30"/>
            <p:cNvSpPr/>
            <p:nvPr/>
          </p:nvSpPr>
          <p:spPr>
            <a:xfrm>
              <a:off x="2952720" y="3852720"/>
              <a:ext cx="3927600" cy="9169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Picture 11" descr=""/>
            <p:cNvPicPr/>
            <p:nvPr/>
          </p:nvPicPr>
          <p:blipFill>
            <a:blip r:embed="rId4"/>
            <a:stretch/>
          </p:blipFill>
          <p:spPr>
            <a:xfrm>
              <a:off x="3146400" y="3874680"/>
              <a:ext cx="3519720" cy="8733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0" name="Picture 12" descr=""/>
          <p:cNvPicPr/>
          <p:nvPr/>
        </p:nvPicPr>
        <p:blipFill>
          <a:blip r:embed="rId5"/>
          <a:stretch/>
        </p:blipFill>
        <p:spPr>
          <a:xfrm>
            <a:off x="3024360" y="5618160"/>
            <a:ext cx="3781080" cy="847800"/>
          </a:xfrm>
          <a:prstGeom prst="rect">
            <a:avLst/>
          </a:prstGeom>
          <a:ln w="0">
            <a:noFill/>
          </a:ln>
        </p:spPr>
      </p:pic>
      <p:sp>
        <p:nvSpPr>
          <p:cNvPr id="61" name="순서도: 병합 35"/>
          <p:cNvSpPr/>
          <p:nvPr/>
        </p:nvSpPr>
        <p:spPr>
          <a:xfrm>
            <a:off x="4535640" y="3475080"/>
            <a:ext cx="664920" cy="217440"/>
          </a:xfrm>
          <a:prstGeom prst="flowChartMerg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순서도: 병합 36"/>
          <p:cNvSpPr/>
          <p:nvPr/>
        </p:nvSpPr>
        <p:spPr>
          <a:xfrm>
            <a:off x="4519440" y="1863720"/>
            <a:ext cx="665280" cy="217440"/>
          </a:xfrm>
          <a:prstGeom prst="flowChartMerg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8"/>
          <p:cNvSpPr/>
          <p:nvPr/>
        </p:nvSpPr>
        <p:spPr>
          <a:xfrm>
            <a:off x="3976560" y="2874960"/>
            <a:ext cx="65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5218200" y="2876400"/>
            <a:ext cx="655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g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1"/>
          <p:cNvSpPr/>
          <p:nvPr/>
        </p:nvSpPr>
        <p:spPr>
          <a:xfrm>
            <a:off x="4005360" y="2673360"/>
            <a:ext cx="173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sistance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40"/>
          <p:cNvSpPr/>
          <p:nvPr/>
        </p:nvSpPr>
        <p:spPr>
          <a:xfrm>
            <a:off x="6321600" y="2176560"/>
            <a:ext cx="160200" cy="160200"/>
          </a:xfrm>
          <a:prstGeom prst="ellipse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41"/>
          <p:cNvSpPr/>
          <p:nvPr/>
        </p:nvSpPr>
        <p:spPr>
          <a:xfrm>
            <a:off x="4775040" y="2409840"/>
            <a:ext cx="160560" cy="160200"/>
          </a:xfrm>
          <a:prstGeom prst="ellipse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42"/>
          <p:cNvSpPr/>
          <p:nvPr/>
        </p:nvSpPr>
        <p:spPr>
          <a:xfrm>
            <a:off x="6634080" y="2220840"/>
            <a:ext cx="160560" cy="162000"/>
          </a:xfrm>
          <a:prstGeom prst="ellipse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43"/>
          <p:cNvSpPr/>
          <p:nvPr/>
        </p:nvSpPr>
        <p:spPr>
          <a:xfrm>
            <a:off x="6321600" y="2481120"/>
            <a:ext cx="160200" cy="1605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44"/>
          <p:cNvSpPr/>
          <p:nvPr/>
        </p:nvSpPr>
        <p:spPr>
          <a:xfrm>
            <a:off x="6647040" y="2444760"/>
            <a:ext cx="160200" cy="1602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Oval 45"/>
          <p:cNvSpPr/>
          <p:nvPr/>
        </p:nvSpPr>
        <p:spPr>
          <a:xfrm>
            <a:off x="6456240" y="2301840"/>
            <a:ext cx="162000" cy="1602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46"/>
          <p:cNvSpPr/>
          <p:nvPr/>
        </p:nvSpPr>
        <p:spPr>
          <a:xfrm>
            <a:off x="6161040" y="2365200"/>
            <a:ext cx="160560" cy="1605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Oval 47"/>
          <p:cNvSpPr/>
          <p:nvPr/>
        </p:nvSpPr>
        <p:spPr>
          <a:xfrm>
            <a:off x="6883560" y="2360520"/>
            <a:ext cx="160200" cy="1605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Oval 48"/>
          <p:cNvSpPr/>
          <p:nvPr/>
        </p:nvSpPr>
        <p:spPr>
          <a:xfrm>
            <a:off x="4967280" y="2320920"/>
            <a:ext cx="160200" cy="1602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49"/>
          <p:cNvSpPr/>
          <p:nvPr/>
        </p:nvSpPr>
        <p:spPr>
          <a:xfrm>
            <a:off x="4422600" y="2935440"/>
            <a:ext cx="16056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Oval 50"/>
          <p:cNvSpPr/>
          <p:nvPr/>
        </p:nvSpPr>
        <p:spPr>
          <a:xfrm>
            <a:off x="4765680" y="2927520"/>
            <a:ext cx="162000" cy="160200"/>
          </a:xfrm>
          <a:prstGeom prst="ellipse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Oval 51"/>
          <p:cNvSpPr/>
          <p:nvPr/>
        </p:nvSpPr>
        <p:spPr>
          <a:xfrm>
            <a:off x="5092560" y="2925720"/>
            <a:ext cx="160560" cy="1620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Straight Arrow Connector 52"/>
          <p:cNvCxnSpPr/>
          <p:nvPr/>
        </p:nvCxnSpPr>
        <p:spPr>
          <a:xfrm flipV="1">
            <a:off x="3731760" y="2409480"/>
            <a:ext cx="1051560" cy="216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9" name="Straight Arrow Connector 53"/>
          <p:cNvCxnSpPr/>
          <p:nvPr/>
        </p:nvCxnSpPr>
        <p:spPr>
          <a:xfrm>
            <a:off x="5221080" y="2418840"/>
            <a:ext cx="795960" cy="252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Oval 54"/>
          <p:cNvSpPr/>
          <p:nvPr/>
        </p:nvSpPr>
        <p:spPr>
          <a:xfrm>
            <a:off x="2970360" y="2201760"/>
            <a:ext cx="160200" cy="160560"/>
          </a:xfrm>
          <a:prstGeom prst="ellipse">
            <a:avLst/>
          </a:prstGeom>
          <a:solidFill>
            <a:srgbClr val="7f7f7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55"/>
          <p:cNvSpPr/>
          <p:nvPr/>
        </p:nvSpPr>
        <p:spPr>
          <a:xfrm>
            <a:off x="3181320" y="2222640"/>
            <a:ext cx="16020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56"/>
          <p:cNvSpPr/>
          <p:nvPr/>
        </p:nvSpPr>
        <p:spPr>
          <a:xfrm>
            <a:off x="3333600" y="2374920"/>
            <a:ext cx="16056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57"/>
          <p:cNvSpPr/>
          <p:nvPr/>
        </p:nvSpPr>
        <p:spPr>
          <a:xfrm>
            <a:off x="3181320" y="2427120"/>
            <a:ext cx="160200" cy="1605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58"/>
          <p:cNvSpPr/>
          <p:nvPr/>
        </p:nvSpPr>
        <p:spPr>
          <a:xfrm>
            <a:off x="3494160" y="2293920"/>
            <a:ext cx="16020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59"/>
          <p:cNvSpPr/>
          <p:nvPr/>
        </p:nvSpPr>
        <p:spPr>
          <a:xfrm>
            <a:off x="2809800" y="2324160"/>
            <a:ext cx="16056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Oval 60"/>
          <p:cNvSpPr/>
          <p:nvPr/>
        </p:nvSpPr>
        <p:spPr>
          <a:xfrm>
            <a:off x="3019320" y="2382840"/>
            <a:ext cx="162000" cy="1602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Oval 61"/>
          <p:cNvSpPr/>
          <p:nvPr/>
        </p:nvSpPr>
        <p:spPr>
          <a:xfrm>
            <a:off x="3537000" y="2484360"/>
            <a:ext cx="160200" cy="1605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5"/>
          <p:cNvSpPr/>
          <p:nvPr/>
        </p:nvSpPr>
        <p:spPr>
          <a:xfrm>
            <a:off x="3840120" y="2135160"/>
            <a:ext cx="1233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2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2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66"/>
          <p:cNvSpPr/>
          <p:nvPr/>
        </p:nvSpPr>
        <p:spPr>
          <a:xfrm>
            <a:off x="3714840" y="2382840"/>
            <a:ext cx="123336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3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4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7"/>
          <p:cNvSpPr/>
          <p:nvPr/>
        </p:nvSpPr>
        <p:spPr>
          <a:xfrm>
            <a:off x="2238480" y="2301840"/>
            <a:ext cx="89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08T06:57:48Z</dcterms:created>
  <dc:creator>S Nam</dc:creator>
  <dc:description/>
  <dc:language>en-US</dc:language>
  <cp:lastModifiedBy>S Nam</cp:lastModifiedBy>
  <dcterms:modified xsi:type="dcterms:W3CDTF">2012-12-10T05:04:39Z</dcterms:modified>
  <cp:revision>123</cp:revision>
  <dc:subject/>
  <dc:title>Switch of transcription factor-miRNA-target circuits during drug resistance progress</dc:title>
</cp:coreProperties>
</file>